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0" r:id="rId2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81" autoAdjust="0"/>
    <p:restoredTop sz="94660"/>
  </p:normalViewPr>
  <p:slideViewPr>
    <p:cSldViewPr snapToGrid="0">
      <p:cViewPr varScale="1">
        <p:scale>
          <a:sx n="56" d="100"/>
          <a:sy n="56" d="100"/>
        </p:scale>
        <p:origin x="125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17588B-19F5-4DD8-AD7C-F575FE934FC7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4F7F04-80A5-4E09-A084-77EA641FB6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88940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4F7F04-80A5-4E09-A084-77EA641FB6B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414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0CCBD-4021-4A43-A714-EB3288C0DBAF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7C41-8571-47B0-8EF5-E53C8F55E8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344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0CCBD-4021-4A43-A714-EB3288C0DBAF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7C41-8571-47B0-8EF5-E53C8F55E8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65442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0CCBD-4021-4A43-A714-EB3288C0DBAF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7C41-8571-47B0-8EF5-E53C8F55E8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60691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0CCBD-4021-4A43-A714-EB3288C0DBAF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7C41-8571-47B0-8EF5-E53C8F55E8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16892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0CCBD-4021-4A43-A714-EB3288C0DBAF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7C41-8571-47B0-8EF5-E53C8F55E8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6520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0CCBD-4021-4A43-A714-EB3288C0DBAF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7C41-8571-47B0-8EF5-E53C8F55E8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0495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0CCBD-4021-4A43-A714-EB3288C0DBAF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7C41-8571-47B0-8EF5-E53C8F55E8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56241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0CCBD-4021-4A43-A714-EB3288C0DBAF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7C41-8571-47B0-8EF5-E53C8F55E8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43563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0CCBD-4021-4A43-A714-EB3288C0DBAF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7C41-8571-47B0-8EF5-E53C8F55E8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13005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0CCBD-4021-4A43-A714-EB3288C0DBAF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7C41-8571-47B0-8EF5-E53C8F55E8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30286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0CCBD-4021-4A43-A714-EB3288C0DBAF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7C41-8571-47B0-8EF5-E53C8F55E8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459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B0CCBD-4021-4A43-A714-EB3288C0DBAF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C17C41-8571-47B0-8EF5-E53C8F55E8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93102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57200" y="228600"/>
            <a:ext cx="1905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Table 3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20620604"/>
              </p:ext>
            </p:extLst>
          </p:nvPr>
        </p:nvGraphicFramePr>
        <p:xfrm>
          <a:off x="525916" y="2062567"/>
          <a:ext cx="5915025" cy="2364339"/>
        </p:xfrm>
        <a:graphic>
          <a:graphicData uri="http://schemas.openxmlformats.org/drawingml/2006/table">
            <a:tbl>
              <a:tblPr/>
              <a:tblGrid>
                <a:gridCol w="901443">
                  <a:extLst>
                    <a:ext uri="{9D8B030D-6E8A-4147-A177-3AD203B41FA5}">
                      <a16:colId xmlns:a16="http://schemas.microsoft.com/office/drawing/2014/main" val="4267431294"/>
                    </a:ext>
                  </a:extLst>
                </a:gridCol>
                <a:gridCol w="779025">
                  <a:extLst>
                    <a:ext uri="{9D8B030D-6E8A-4147-A177-3AD203B41FA5}">
                      <a16:colId xmlns:a16="http://schemas.microsoft.com/office/drawing/2014/main" val="3300849313"/>
                    </a:ext>
                  </a:extLst>
                </a:gridCol>
                <a:gridCol w="534189">
                  <a:extLst>
                    <a:ext uri="{9D8B030D-6E8A-4147-A177-3AD203B41FA5}">
                      <a16:colId xmlns:a16="http://schemas.microsoft.com/office/drawing/2014/main" val="3239333045"/>
                    </a:ext>
                  </a:extLst>
                </a:gridCol>
                <a:gridCol w="459068">
                  <a:extLst>
                    <a:ext uri="{9D8B030D-6E8A-4147-A177-3AD203B41FA5}">
                      <a16:colId xmlns:a16="http://schemas.microsoft.com/office/drawing/2014/main" val="1896813269"/>
                    </a:ext>
                  </a:extLst>
                </a:gridCol>
                <a:gridCol w="726162">
                  <a:extLst>
                    <a:ext uri="{9D8B030D-6E8A-4147-A177-3AD203B41FA5}">
                      <a16:colId xmlns:a16="http://schemas.microsoft.com/office/drawing/2014/main" val="3855968816"/>
                    </a:ext>
                  </a:extLst>
                </a:gridCol>
                <a:gridCol w="600962">
                  <a:extLst>
                    <a:ext uri="{9D8B030D-6E8A-4147-A177-3AD203B41FA5}">
                      <a16:colId xmlns:a16="http://schemas.microsoft.com/office/drawing/2014/main" val="1595016524"/>
                    </a:ext>
                  </a:extLst>
                </a:gridCol>
                <a:gridCol w="612091">
                  <a:extLst>
                    <a:ext uri="{9D8B030D-6E8A-4147-A177-3AD203B41FA5}">
                      <a16:colId xmlns:a16="http://schemas.microsoft.com/office/drawing/2014/main" val="4238346018"/>
                    </a:ext>
                  </a:extLst>
                </a:gridCol>
                <a:gridCol w="656607">
                  <a:extLst>
                    <a:ext uri="{9D8B030D-6E8A-4147-A177-3AD203B41FA5}">
                      <a16:colId xmlns:a16="http://schemas.microsoft.com/office/drawing/2014/main" val="956853278"/>
                    </a:ext>
                  </a:extLst>
                </a:gridCol>
                <a:gridCol w="645478">
                  <a:extLst>
                    <a:ext uri="{9D8B030D-6E8A-4147-A177-3AD203B41FA5}">
                      <a16:colId xmlns:a16="http://schemas.microsoft.com/office/drawing/2014/main" val="647995064"/>
                    </a:ext>
                  </a:extLst>
                </a:gridCol>
              </a:tblGrid>
              <a:tr h="3425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et</a:t>
                      </a:r>
                    </a:p>
                  </a:txBody>
                  <a:tcPr marL="8355" marR="8355" marT="835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senic (ppb)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terval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ea Under the Curve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rcent Change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 value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gnificant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tivity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5373714"/>
                  </a:ext>
                </a:extLst>
              </a:tr>
              <a:tr h="16709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inc Adequate</a:t>
                      </a:r>
                    </a:p>
                  </a:txBody>
                  <a:tcPr marL="8355" marR="8355" marT="835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ark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9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84.9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3676098"/>
                  </a:ext>
                </a:extLst>
              </a:tr>
              <a:tr h="16709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inc Adequate</a:t>
                      </a:r>
                    </a:p>
                  </a:txBody>
                  <a:tcPr marL="8355" marR="8355" marT="835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ark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4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58.0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6.9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active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744122"/>
                  </a:ext>
                </a:extLst>
              </a:tr>
              <a:tr h="16709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inc Adequate</a:t>
                      </a:r>
                    </a:p>
                  </a:txBody>
                  <a:tcPr marL="8355" marR="8355" marT="835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0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ark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8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89.7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8.6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active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8414362"/>
                  </a:ext>
                </a:extLst>
              </a:tr>
              <a:tr h="16709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inc Deficient</a:t>
                      </a:r>
                    </a:p>
                  </a:txBody>
                  <a:tcPr marL="8355" marR="8355" marT="835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ark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0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73.3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9.7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active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13954472"/>
                  </a:ext>
                </a:extLst>
              </a:tr>
              <a:tr h="16709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inc Deficient</a:t>
                      </a:r>
                    </a:p>
                  </a:txBody>
                  <a:tcPr marL="8355" marR="8355" marT="835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ark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2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83.8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1.6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active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9770054"/>
                  </a:ext>
                </a:extLst>
              </a:tr>
              <a:tr h="17544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inc Deficient</a:t>
                      </a:r>
                    </a:p>
                  </a:txBody>
                  <a:tcPr marL="8355" marR="8355" marT="835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0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ark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8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56.6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6.0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poactive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8827042"/>
                  </a:ext>
                </a:extLst>
              </a:tr>
              <a:tr h="16709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inc Adequate</a:t>
                      </a:r>
                    </a:p>
                  </a:txBody>
                  <a:tcPr marL="8355" marR="8355" marT="835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ght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9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2.7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4289377"/>
                  </a:ext>
                </a:extLst>
              </a:tr>
              <a:tr h="16709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inc Adequate</a:t>
                      </a:r>
                    </a:p>
                  </a:txBody>
                  <a:tcPr marL="8355" marR="8355" marT="835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ght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4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5.1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4.3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5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hange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2098952"/>
                  </a:ext>
                </a:extLst>
              </a:tr>
              <a:tr h="16709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inc Adequate</a:t>
                      </a:r>
                    </a:p>
                  </a:txBody>
                  <a:tcPr marL="8355" marR="8355" marT="835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0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ght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8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6.1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69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hange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5053265"/>
                  </a:ext>
                </a:extLst>
              </a:tr>
              <a:tr h="16709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inc Deficient</a:t>
                      </a:r>
                    </a:p>
                  </a:txBody>
                  <a:tcPr marL="8355" marR="8355" marT="835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ght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0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6.2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1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64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hange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31896548"/>
                  </a:ext>
                </a:extLst>
              </a:tr>
              <a:tr h="16709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inc Deficient</a:t>
                      </a:r>
                    </a:p>
                  </a:txBody>
                  <a:tcPr marL="8355" marR="8355" marT="835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ght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2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4.5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6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6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hange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3793343"/>
                  </a:ext>
                </a:extLst>
              </a:tr>
              <a:tr h="17544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inc Deficient</a:t>
                      </a:r>
                    </a:p>
                  </a:txBody>
                  <a:tcPr marL="8355" marR="8355" marT="835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0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ght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8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4.2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8.5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6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change</a:t>
                      </a:r>
                    </a:p>
                  </a:txBody>
                  <a:tcPr marL="8355" marR="8355" marT="83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362814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944068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517</TotalTime>
  <Words>153</Words>
  <Application>Microsoft Office PowerPoint</Application>
  <PresentationFormat>On-screen Show (4:3)</PresentationFormat>
  <Paragraphs>11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Oregon Stat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aver, Laura</dc:creator>
  <cp:lastModifiedBy>Beaver, Laura</cp:lastModifiedBy>
  <cp:revision>114</cp:revision>
  <cp:lastPrinted>2017-01-10T20:43:22Z</cp:lastPrinted>
  <dcterms:created xsi:type="dcterms:W3CDTF">2016-12-13T00:19:40Z</dcterms:created>
  <dcterms:modified xsi:type="dcterms:W3CDTF">2017-05-10T19:58:46Z</dcterms:modified>
</cp:coreProperties>
</file>